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1" r:id="rId2"/>
    <p:sldId id="262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82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4/11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30499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26467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4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JP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55517" y="6197242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13331" y="578856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Tramunt</a:t>
            </a:r>
            <a:r>
              <a:rPr lang="en-GB" dirty="0"/>
              <a:t> et al (2020) Diabetologia DOI 10.1007/s00125-019-05040-3 </a:t>
            </a:r>
          </a:p>
          <a:p>
            <a:r>
              <a:rPr lang="en-GB" sz="1200" dirty="0"/>
              <a:t>©The Authors 2019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504" y="143937"/>
            <a:ext cx="892899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Main sex dimorphisms in body composition and metabolic homeostasis in humans (premenopausal women vs age-matched men) </a:t>
            </a:r>
          </a:p>
        </p:txBody>
      </p:sp>
      <p:pic>
        <p:nvPicPr>
          <p:cNvPr id="5" name="Picture 4" descr="A close up of a sign&#10;&#10;Description automatically generated">
            <a:extLst>
              <a:ext uri="{FF2B5EF4-FFF2-40B4-BE49-F238E27FC236}">
                <a16:creationId xmlns:a16="http://schemas.microsoft.com/office/drawing/2014/main" id="{2B64B912-37EE-4E3D-BEBE-76852551BF4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7" y="938251"/>
            <a:ext cx="7162611" cy="50861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93388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55517" y="6197242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13331" y="578856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Tramunt</a:t>
            </a:r>
            <a:r>
              <a:rPr lang="en-GB" dirty="0"/>
              <a:t> et al (2020) Diabetologia DOI 10.1007/s00125-019-05040-3 </a:t>
            </a:r>
          </a:p>
          <a:p>
            <a:r>
              <a:rPr lang="en-GB" sz="1200"/>
              <a:t>©</a:t>
            </a:r>
            <a:r>
              <a:rPr lang="en-GB" sz="1200" dirty="0"/>
              <a:t>The Authors 2019. Distributed under the terms of the CC BY 4.0 Attribution License (</a:t>
            </a:r>
            <a:r>
              <a:rPr lang="en-GB" sz="1200" dirty="0">
                <a:hlinkClick r:id="rId4"/>
              </a:rPr>
              <a:t>http://creativecommons.org/licenses/by/4.0/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504" y="186857"/>
            <a:ext cx="892899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issue-specific actions of oestrogens on energy balance and metabolic regulation in rodent models</a:t>
            </a:r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016B0203-1661-4E0E-BFFE-FF5A3CED031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5977" y="894743"/>
            <a:ext cx="7432045" cy="51671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028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</TotalTime>
  <Words>113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Shelley Williams</cp:lastModifiedBy>
  <cp:revision>34</cp:revision>
  <dcterms:created xsi:type="dcterms:W3CDTF">2016-06-15T12:53:43Z</dcterms:created>
  <dcterms:modified xsi:type="dcterms:W3CDTF">2019-11-14T12:29:39Z</dcterms:modified>
</cp:coreProperties>
</file>